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9" r:id="rId2"/>
    <p:sldId id="260" r:id="rId3"/>
    <p:sldId id="261" r:id="rId4"/>
    <p:sldId id="262" r:id="rId5"/>
    <p:sldId id="257" r:id="rId6"/>
    <p:sldId id="258" r:id="rId7"/>
    <p:sldId id="263" r:id="rId8"/>
    <p:sldId id="264" r:id="rId9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0" autoAdjust="0"/>
    <p:restoredTop sz="94660"/>
  </p:normalViewPr>
  <p:slideViewPr>
    <p:cSldViewPr snapToGrid="0" showGuides="1">
      <p:cViewPr>
        <p:scale>
          <a:sx n="96" d="100"/>
          <a:sy n="96" d="100"/>
        </p:scale>
        <p:origin x="2220" y="-39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557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722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88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945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45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306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866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348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037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853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801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2CC74-EADE-4061-9B25-FAB13F79D65C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7A64F3-DAB7-43FE-86D3-D86E42B6D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555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841093" y="3908956"/>
            <a:ext cx="422381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 smtClean="0">
                <a:latin typeface="Helvetica" pitchFamily="34" charset="0"/>
              </a:rPr>
              <a:t>Table S1: Detection of transgenic plant-derived transcripts from </a:t>
            </a:r>
            <a:r>
              <a:rPr lang="en-US" sz="800" b="1" dirty="0" err="1" smtClean="0">
                <a:latin typeface="Helvetica" pitchFamily="34" charset="0"/>
              </a:rPr>
              <a:t>RNAseq</a:t>
            </a:r>
            <a:r>
              <a:rPr lang="en-US" sz="800" b="1" dirty="0" smtClean="0">
                <a:latin typeface="Helvetica" pitchFamily="34" charset="0"/>
              </a:rPr>
              <a:t> (total RNA) and IC-RT-PCR NGS (virus </a:t>
            </a:r>
            <a:r>
              <a:rPr lang="en-US" sz="800" b="1" dirty="0" err="1" smtClean="0">
                <a:latin typeface="Helvetica" pitchFamily="34" charset="0"/>
              </a:rPr>
              <a:t>encapsidated</a:t>
            </a:r>
            <a:r>
              <a:rPr lang="en-US" sz="800" b="1" dirty="0" smtClean="0">
                <a:latin typeface="Helvetica" pitchFamily="34" charset="0"/>
              </a:rPr>
              <a:t> RNA) based techniques</a:t>
            </a:r>
            <a:r>
              <a:rPr lang="en-US" sz="800" dirty="0" smtClean="0">
                <a:latin typeface="Helvetica" pitchFamily="34" charset="0"/>
              </a:rPr>
              <a:t>. </a:t>
            </a:r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1683985"/>
              </p:ext>
            </p:extLst>
          </p:nvPr>
        </p:nvGraphicFramePr>
        <p:xfrm>
          <a:off x="2575607" y="1334056"/>
          <a:ext cx="4159998" cy="2458796"/>
        </p:xfrm>
        <a:graphic>
          <a:graphicData uri="http://schemas.openxmlformats.org/drawingml/2006/table">
            <a:tbl>
              <a:tblPr/>
              <a:tblGrid>
                <a:gridCol w="669574"/>
                <a:gridCol w="669574"/>
                <a:gridCol w="669574"/>
                <a:gridCol w="537819"/>
                <a:gridCol w="537819"/>
                <a:gridCol w="537819"/>
                <a:gridCol w="537819"/>
              </a:tblGrid>
              <a:tr h="66156"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genic sequences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66156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13-CP (1515nt)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PTII (796nt)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744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s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reads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/0.99</a:t>
                      </a:r>
                      <a:r>
                        <a:rPr lang="en-US" sz="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/0.7*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7/0,99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/0.7*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Aseq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619,52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5,06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x15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389,44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8,919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,014,63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9,21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595,83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2,678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,722,498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5,50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,932,88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0,159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,825,91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4,17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,214,317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2,45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,328,558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3,809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,872,54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,20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598,957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,51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,381,18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8,94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,561,55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4,59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57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,440,27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,49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8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885,209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7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6,94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7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330,08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,57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,623,79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9,50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,999,98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,85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640,62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,38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,771,21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6,33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556,79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,37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,967,638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,608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i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,682,439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086,63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i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,065,98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6,04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i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,040,27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2,72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i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,129,87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2,828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C-RT-PCR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08,58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5,61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x25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b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67,01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9,766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21,548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4,812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b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32,89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6,57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24,453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,65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b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24,069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8,36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6156"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756,721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8,31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8912"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b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55,544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1,805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5752" marR="5752" marT="275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73406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88393" y="3839962"/>
            <a:ext cx="762008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 smtClean="0">
                <a:latin typeface="Helvetica" pitchFamily="34" charset="0"/>
              </a:rPr>
              <a:t>Table S2: </a:t>
            </a:r>
            <a:r>
              <a:rPr lang="en-US" sz="800" b="1" dirty="0">
                <a:latin typeface="Helvetica" pitchFamily="34" charset="0"/>
              </a:rPr>
              <a:t>Sanitary status</a:t>
            </a:r>
            <a:r>
              <a:rPr lang="en-US" sz="800" dirty="0">
                <a:latin typeface="Helvetica" pitchFamily="34" charset="0"/>
              </a:rPr>
              <a:t>. </a:t>
            </a:r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5760046"/>
              </p:ext>
            </p:extLst>
          </p:nvPr>
        </p:nvGraphicFramePr>
        <p:xfrm>
          <a:off x="793002" y="721498"/>
          <a:ext cx="8319999" cy="2964245"/>
        </p:xfrm>
        <a:graphic>
          <a:graphicData uri="http://schemas.openxmlformats.org/drawingml/2006/table">
            <a:tbl>
              <a:tblPr/>
              <a:tblGrid>
                <a:gridCol w="849819"/>
                <a:gridCol w="1247315"/>
                <a:gridCol w="995110"/>
                <a:gridCol w="995110"/>
                <a:gridCol w="995110"/>
                <a:gridCol w="1247315"/>
                <a:gridCol w="995110"/>
                <a:gridCol w="995110"/>
              </a:tblGrid>
              <a:tr h="82150">
                <a:tc>
                  <a:txBody>
                    <a:bodyPr/>
                    <a:lstStyle/>
                    <a:p>
                      <a:pPr algn="ctr" fontAlgn="b"/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LV consensus (without UTR)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iroid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 name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A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A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tRNA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SPaV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Vd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YSVd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ze (nt)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85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33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0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72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s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med reads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1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619,526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461.3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651.1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523.7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0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.6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2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389,442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637.6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066.7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020.0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.0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1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3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,014,632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03.5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587.2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368.9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5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2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4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595,835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05.3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347.7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7.9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8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9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5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,934,792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87.9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054.5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758.6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9.3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0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8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6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,328,600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61.2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417.2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5.9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2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9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WTRav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.3M ± 4.6M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42.46 ± 210.0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687.45 ± 654.5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682.54 ± 364.2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50 ± 21.2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0 ± 9.1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8 ± 7.9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70AD47"/>
                          </a:solidFill>
                          <a:effectLst/>
                          <a:latin typeface="Calibri" panose="020F0502020204030204" pitchFamily="34" charset="0"/>
                        </a:rPr>
                        <a:t>ScWT1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,825,915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357.9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577.6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73.0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4.0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.6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.8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70AD47"/>
                          </a:solidFill>
                          <a:effectLst/>
                          <a:latin typeface="Calibri" panose="020F0502020204030204" pitchFamily="34" charset="0"/>
                        </a:rPr>
                        <a:t>ScWT2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,214,317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8.2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207.2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5.3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2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.7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4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70AD47"/>
                          </a:solidFill>
                          <a:effectLst/>
                          <a:latin typeface="Calibri" panose="020F0502020204030204" pitchFamily="34" charset="0"/>
                        </a:rPr>
                        <a:t>ScWT3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,328,558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1.,0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046.4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2.0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2.5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.1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6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70AD47"/>
                          </a:solidFill>
                          <a:effectLst/>
                          <a:latin typeface="Calibri" panose="020F0502020204030204" pitchFamily="34" charset="0"/>
                        </a:rPr>
                        <a:t>ScWT4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,872,544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4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64.,4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7.3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2.9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.8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0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70AD47"/>
                          </a:solidFill>
                          <a:effectLst/>
                          <a:latin typeface="Calibri" panose="020F0502020204030204" pitchFamily="34" charset="0"/>
                        </a:rPr>
                        <a:t>ScWT5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598,957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15.6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702.1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6.9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3.6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5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1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70AD47"/>
                          </a:solidFill>
                          <a:effectLst/>
                          <a:latin typeface="Calibri" panose="020F0502020204030204" pitchFamily="34" charset="0"/>
                        </a:rPr>
                        <a:t>ScWT6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,381,186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647.5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096.9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31.5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.4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7.4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8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548235"/>
                          </a:solidFill>
                          <a:effectLst/>
                          <a:latin typeface="Calibri" panose="020F0502020204030204" pitchFamily="34" charset="0"/>
                        </a:rPr>
                        <a:t>ScWTav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2M ± 7.5M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95.74 ± 137.3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765.81 ± 360.8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1.05 ± 166.5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8.10 ± 80.8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.06 ± 20.2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.01 ± 11.6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GMR1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,561,556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68.7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123.3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5.6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GMR2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,440,271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34.7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13.5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3.4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GMR3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885,209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019.5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307.5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69.6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GMR4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330,086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7.2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96.6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87.3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GMR5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,623,793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69.5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240.7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7.4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305496"/>
                          </a:solidFill>
                          <a:effectLst/>
                          <a:latin typeface="Calibri" panose="020F0502020204030204" pitchFamily="34" charset="0"/>
                        </a:rPr>
                        <a:t>GMRav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4M ± 5.2M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349.96 ± 197.8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956.36 ± 424.2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30.70 ± 150.2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 ± 0.0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 ± 0.1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 ± 0.0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D966"/>
                          </a:solidFill>
                          <a:effectLst/>
                          <a:latin typeface="Calibri" panose="020F0502020204030204" pitchFamily="34" charset="0"/>
                        </a:rPr>
                        <a:t>ScGM1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,999,982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4.1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381.9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0.4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4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5.9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3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D966"/>
                          </a:solidFill>
                          <a:effectLst/>
                          <a:latin typeface="Calibri" panose="020F0502020204030204" pitchFamily="34" charset="0"/>
                        </a:rPr>
                        <a:t>ScGM2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640,624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0.2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88.5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1.7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3.9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1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D966"/>
                          </a:solidFill>
                          <a:effectLst/>
                          <a:latin typeface="Calibri" panose="020F0502020204030204" pitchFamily="34" charset="0"/>
                        </a:rPr>
                        <a:t>ScGM3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,771,212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59.1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814.9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340.1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8.5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3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D966"/>
                          </a:solidFill>
                          <a:effectLst/>
                          <a:latin typeface="Calibri" panose="020F0502020204030204" pitchFamily="34" charset="0"/>
                        </a:rPr>
                        <a:t>ScGM4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556,796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4.9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61.1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1.3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3.4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6.7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6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D966"/>
                          </a:solidFill>
                          <a:effectLst/>
                          <a:latin typeface="Calibri" panose="020F0502020204030204" pitchFamily="34" charset="0"/>
                        </a:rPr>
                        <a:t>ScGM5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,967,638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5.3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31.2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0.6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2.6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.6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9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av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3M ± 6.4M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8.78 ± 83.3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95.55 ± 230.7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8.84 ± 186.0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.97 ± 83.9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6.35 ± 10.2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90 ± 6.3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8995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OVA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r>
                        <a:rPr lang="en-US" sz="5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2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8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1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2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1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4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49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E-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i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,682,439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355.3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,083.3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251.0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3.4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57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0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70AD47"/>
                          </a:solidFill>
                          <a:effectLst/>
                          <a:latin typeface="Calibri" panose="020F0502020204030204" pitchFamily="34" charset="0"/>
                        </a:rPr>
                        <a:t>ScWTi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,065,985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24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635.9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80.4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5.4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.3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7.2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GMRi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,040,271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369.8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,457.9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480.25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i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,129,875</a:t>
                      </a:r>
                    </a:p>
                  </a:txBody>
                  <a:tcPr marL="7141" marR="7141" marT="342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654.64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423.91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2,.56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5.7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7.30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2.83</a:t>
                      </a:r>
                    </a:p>
                  </a:txBody>
                  <a:tcPr marL="7141" marR="7141" marT="34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26991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07037" y="3085436"/>
            <a:ext cx="806411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 smtClean="0">
                <a:latin typeface="Helvetica" pitchFamily="34" charset="0"/>
              </a:rPr>
              <a:t>Table S3: SNPs quantification</a:t>
            </a:r>
            <a:r>
              <a:rPr lang="en-US" sz="800" dirty="0">
                <a:latin typeface="Helvetica" pitchFamily="34" charset="0"/>
              </a:rPr>
              <a:t>. </a:t>
            </a:r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7056787"/>
              </p:ext>
            </p:extLst>
          </p:nvPr>
        </p:nvGraphicFramePr>
        <p:xfrm>
          <a:off x="681038" y="1154363"/>
          <a:ext cx="8320008" cy="1618311"/>
        </p:xfrm>
        <a:graphic>
          <a:graphicData uri="http://schemas.openxmlformats.org/drawingml/2006/table">
            <a:tbl>
              <a:tblPr/>
              <a:tblGrid>
                <a:gridCol w="662182"/>
                <a:gridCol w="544699"/>
                <a:gridCol w="544699"/>
                <a:gridCol w="544699"/>
                <a:gridCol w="544699"/>
                <a:gridCol w="544699"/>
                <a:gridCol w="544699"/>
                <a:gridCol w="544699"/>
                <a:gridCol w="544699"/>
                <a:gridCol w="544699"/>
                <a:gridCol w="544699"/>
                <a:gridCol w="544699"/>
                <a:gridCol w="544699"/>
                <a:gridCol w="544699"/>
                <a:gridCol w="576739"/>
              </a:tblGrid>
              <a:tr h="59753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3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A1 consensus without UTR (6855 nt)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3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A2 consensus without UTR (3333 nt)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3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P consensus (1515nt)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3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tRNA consensus (1004 nt)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59753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%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%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%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%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79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1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3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07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1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3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6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1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79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3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6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2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05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6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6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0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WTR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47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04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20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4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9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6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8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2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00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9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3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01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60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3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2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3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WT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27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9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28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8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3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6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9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7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0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23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62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0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72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9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9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GMR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28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66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4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2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20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4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4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3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4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3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9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0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9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4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4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9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5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67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FFC000"/>
                          </a:solidFill>
                          <a:effectLst/>
                          <a:latin typeface="Calibri" panose="020F0502020204030204" pitchFamily="34" charset="0"/>
                        </a:rPr>
                        <a:t>ScGM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0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60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8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OVA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647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r>
                        <a:rPr lang="en-US" sz="3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21</a:t>
                      </a:r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4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1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9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8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5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42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85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0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87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44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0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4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46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15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57</a:t>
                      </a:r>
                    </a:p>
                  </a:txBody>
                  <a:tcPr marL="5194" marR="5194" marT="24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63</a:t>
                      </a:r>
                    </a:p>
                  </a:txBody>
                  <a:tcPr marL="5194" marR="5194" marT="24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64423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5369685" y="3705973"/>
            <a:ext cx="38567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Helvetica" pitchFamily="34" charset="0"/>
              </a:rPr>
              <a:t>Table S4: F</a:t>
            </a:r>
            <a:r>
              <a:rPr lang="en-US" sz="800" b="1" baseline="-25000" dirty="0" smtClean="0">
                <a:latin typeface="Helvetica" pitchFamily="34" charset="0"/>
              </a:rPr>
              <a:t>ST</a:t>
            </a:r>
            <a:r>
              <a:rPr lang="en-US" sz="800" b="1" dirty="0" smtClean="0">
                <a:latin typeface="Helvetica" pitchFamily="34" charset="0"/>
              </a:rPr>
              <a:t> values for each sampling categories.</a:t>
            </a:r>
            <a:endParaRPr lang="en-US" sz="800" dirty="0">
              <a:latin typeface="Helvetica" pitchFamily="34" charset="0"/>
            </a:endParaRPr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3445927"/>
              </p:ext>
            </p:extLst>
          </p:nvPr>
        </p:nvGraphicFramePr>
        <p:xfrm>
          <a:off x="959102" y="344954"/>
          <a:ext cx="8320000" cy="3573864"/>
        </p:xfrm>
        <a:graphic>
          <a:graphicData uri="http://schemas.openxmlformats.org/drawingml/2006/table">
            <a:tbl>
              <a:tblPr/>
              <a:tblGrid>
                <a:gridCol w="440795"/>
                <a:gridCol w="762207"/>
                <a:gridCol w="762207"/>
                <a:gridCol w="762207"/>
                <a:gridCol w="948934"/>
                <a:gridCol w="948934"/>
                <a:gridCol w="459161"/>
                <a:gridCol w="762207"/>
                <a:gridCol w="762207"/>
                <a:gridCol w="762207"/>
                <a:gridCol w="948934"/>
              </a:tblGrid>
              <a:tr h="90859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LV-RNA1 (70 sequences, RNAseq)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LV-RNA2 (44 sequences, RNAseq)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3574"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  <a:r>
                        <a:rPr lang="en-US" sz="600" b="0" i="1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(WTR/SWT/GMR/SGM)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= -0.0466 ; 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 1.0000</a:t>
                      </a:r>
                      <a:endParaRPr lang="en-US" sz="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00" marR="7900" marT="378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  <a:r>
                        <a:rPr lang="en-US" sz="600" b="0" i="1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(WTR/SWT/GMR/SGM)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= 0.0397 ; 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 0.1662</a:t>
                      </a:r>
                      <a:endParaRPr lang="en-US" sz="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00" marR="7900" marT="378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843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r>
                        <a:rPr lang="en-US" sz="6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r>
                        <a:rPr lang="en-US" sz="6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5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2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2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1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5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2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2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6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4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6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6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56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5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</a:tr>
              <a:tr h="946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599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LV-CP (44 sequences, RNAseq)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pt-B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LV-CP minus clade I (35 sequences, RNAseq)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3574"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  <a:r>
                        <a:rPr lang="en-US" sz="600" b="0" i="1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(WTR/SWT/GMR/SGM)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= 0.0532 ; 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 0.1525</a:t>
                      </a:r>
                      <a:endParaRPr lang="en-US" sz="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00" marR="7900" marT="378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  <a:r>
                        <a:rPr lang="en-US" sz="600" b="0" i="1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(WTR/SWT/GMR/SGM)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= -0.0299 ; 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 0.5943</a:t>
                      </a:r>
                      <a:endParaRPr lang="en-US" sz="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00" marR="7900" marT="378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843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r>
                        <a:rPr lang="en-US" sz="6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r>
                        <a:rPr lang="en-US" sz="6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50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6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22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36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11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5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6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0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35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6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7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01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8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</a:tr>
              <a:tr h="946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599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LV-CP (75 sequences, RNAseq)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LV-CP (50 sequences, IC-RT-PCRseq)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3574"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  <a:r>
                        <a:rPr lang="en-US" sz="600" b="0" i="1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(WTR/SWT/GMR/SGM)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= 0.0558 ; 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 0.0557</a:t>
                      </a:r>
                      <a:endParaRPr lang="en-US" sz="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00" marR="7900" marT="378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  <a:r>
                        <a:rPr lang="en-US" sz="600" b="0" i="1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(WTR/SWT/GMR/SGM)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= 0.03913 ; 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 0.12121</a:t>
                      </a:r>
                      <a:endParaRPr lang="en-US" sz="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00" marR="7900" marT="378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843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r>
                        <a:rPr lang="en-US" sz="6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r>
                        <a:rPr lang="en-US" sz="6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0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36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6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0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2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5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6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09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2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1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5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</a:tr>
              <a:tr h="946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90859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LV-RNA3 (31 sequences, RNAseq)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574"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  <a:r>
                        <a:rPr lang="en-US" sz="600" b="0" i="1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(WTR/SWT/GMR/SGM)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= 0.0372 ; 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 0.1095</a:t>
                      </a:r>
                      <a:endParaRPr lang="en-US" sz="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00" marR="7900" marT="378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843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r>
                        <a:rPr lang="en-US" sz="6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8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4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0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1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0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0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1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6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</a:t>
                      </a: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7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900" marR="7900" marT="3786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00" marR="7900" marT="37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829548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7812232" y="858722"/>
            <a:ext cx="1829874" cy="4425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38" b="1" dirty="0"/>
              <a:t>Table S5 (part A): Crossover sites.</a:t>
            </a: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642938"/>
            <a:ext cx="7703763" cy="5572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58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7812232" y="858722"/>
            <a:ext cx="1829874" cy="4425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38" b="1" dirty="0"/>
              <a:t>Table S5 (part B): Crossover sites.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76" y="687219"/>
            <a:ext cx="7768418" cy="50980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2236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189407" y="5657743"/>
            <a:ext cx="416052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 smtClean="0">
                <a:latin typeface="Helvetica" pitchFamily="34" charset="0"/>
              </a:rPr>
              <a:t>Table S6:</a:t>
            </a:r>
            <a:r>
              <a:rPr lang="en-US" sz="800" dirty="0" smtClean="0">
                <a:latin typeface="Helvetica" pitchFamily="34" charset="0"/>
              </a:rPr>
              <a:t> </a:t>
            </a:r>
            <a:r>
              <a:rPr lang="en-US" sz="800" b="1" dirty="0">
                <a:latin typeface="Helvetica" pitchFamily="34" charset="0"/>
              </a:rPr>
              <a:t>Quality control of </a:t>
            </a:r>
            <a:r>
              <a:rPr lang="en-US" sz="800" b="1" dirty="0" err="1" smtClean="0">
                <a:latin typeface="Helvetica" pitchFamily="34" charset="0"/>
              </a:rPr>
              <a:t>DNAseq</a:t>
            </a:r>
            <a:r>
              <a:rPr lang="en-US" sz="800" b="1" dirty="0" smtClean="0">
                <a:latin typeface="Helvetica" pitchFamily="34" charset="0"/>
              </a:rPr>
              <a:t> and </a:t>
            </a:r>
            <a:r>
              <a:rPr lang="en-US" sz="800" b="1" dirty="0" err="1" smtClean="0">
                <a:latin typeface="Helvetica" pitchFamily="34" charset="0"/>
              </a:rPr>
              <a:t>RNAseq</a:t>
            </a:r>
            <a:r>
              <a:rPr lang="en-US" sz="800" dirty="0" smtClean="0">
                <a:latin typeface="Helvetica" pitchFamily="34" charset="0"/>
              </a:rPr>
              <a:t>. </a:t>
            </a:r>
            <a:endParaRPr lang="en-US" sz="800" dirty="0">
              <a:latin typeface="Helvetica" pitchFamily="34" charset="0"/>
            </a:endParaRPr>
          </a:p>
        </p:txBody>
      </p:sp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7947479"/>
              </p:ext>
            </p:extLst>
          </p:nvPr>
        </p:nvGraphicFramePr>
        <p:xfrm>
          <a:off x="3211731" y="483012"/>
          <a:ext cx="4160002" cy="4803766"/>
        </p:xfrm>
        <a:graphic>
          <a:graphicData uri="http://schemas.openxmlformats.org/drawingml/2006/table">
            <a:tbl>
              <a:tblPr/>
              <a:tblGrid>
                <a:gridCol w="741150"/>
                <a:gridCol w="741150"/>
                <a:gridCol w="741150"/>
                <a:gridCol w="1195402"/>
                <a:gridCol w="741150"/>
              </a:tblGrid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reads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s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w reads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 quality check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mes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d trimming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ngth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Aseq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906,88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619,52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x15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567,46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389,44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,337,28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,014,63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838,56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595,83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,934,79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,722,49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,328,60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,932,88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T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,142,99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,825,91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T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,611,21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,214,31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T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,520,59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,328,55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T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,033,78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,872,54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T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695,64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598,95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T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,541,58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,381,18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M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,537,31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,999,98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M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796,34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640,62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M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,161,09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,771,21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.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M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715,19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556,79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M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,105,73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,967,63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,837,98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,561,55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7.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,637,72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,440,27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,051,84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885,20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423,29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330,08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7.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,734,77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,623,79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2250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i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,216,48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,682,43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Ti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,445,78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,065,98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.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Mi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,519,39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,129,87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.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i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,042,43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,040,27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.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C-RT-PCR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a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483,27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08,58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3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x25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Rb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006,30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67,01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.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a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516,24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21,54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2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WTb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25,00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32,89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.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a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45,25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24,45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6.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Rb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60,12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24,06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6.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a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789,39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756,72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5.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GMb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85,44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55,54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6.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So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,688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,33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*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22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4 titanium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So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,03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,34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*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So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,74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,41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*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So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,83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,22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*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So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,60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,45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*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So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,90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91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*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So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,26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3,52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8.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eq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So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5,06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8,68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2.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x25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So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1,87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1,599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6.5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So1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841,48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88,034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5.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So2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7,57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7,22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9.6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84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So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,440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,483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1.7</a:t>
                      </a:r>
                    </a:p>
                  </a:txBody>
                  <a:tcPr marL="7173" marR="7173" marT="34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378640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664644" y="172894"/>
            <a:ext cx="8576712" cy="5528254"/>
            <a:chOff x="65120" y="73889"/>
            <a:chExt cx="5937724" cy="6247062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5120" y="73889"/>
              <a:ext cx="2880000" cy="6247062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22844" y="104740"/>
              <a:ext cx="2880000" cy="4660506"/>
            </a:xfrm>
            <a:prstGeom prst="rect">
              <a:avLst/>
            </a:prstGeom>
          </p:spPr>
        </p:pic>
      </p:grpSp>
      <p:sp>
        <p:nvSpPr>
          <p:cNvPr id="7" name="Rectangle 6"/>
          <p:cNvSpPr/>
          <p:nvPr/>
        </p:nvSpPr>
        <p:spPr>
          <a:xfrm>
            <a:off x="4925233" y="6148408"/>
            <a:ext cx="447224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Helvetica" pitchFamily="34" charset="0"/>
              </a:rPr>
              <a:t>Table </a:t>
            </a:r>
            <a:r>
              <a:rPr lang="en-US" sz="800" b="1" dirty="0" smtClean="0">
                <a:solidFill>
                  <a:srgbClr val="000000"/>
                </a:solidFill>
                <a:latin typeface="Helvetica" pitchFamily="34" charset="0"/>
              </a:rPr>
              <a:t>S7: </a:t>
            </a:r>
            <a:r>
              <a:rPr lang="en-US" sz="800" b="1" dirty="0">
                <a:solidFill>
                  <a:srgbClr val="000000"/>
                </a:solidFill>
                <a:latin typeface="Helvetica" pitchFamily="34" charset="0"/>
              </a:rPr>
              <a:t>List of reference of grapevine-infecting viruses and </a:t>
            </a:r>
            <a:r>
              <a:rPr lang="en-US" sz="800" b="1" dirty="0" err="1" smtClean="0">
                <a:solidFill>
                  <a:srgbClr val="000000"/>
                </a:solidFill>
                <a:latin typeface="Helvetica" pitchFamily="34" charset="0"/>
              </a:rPr>
              <a:t>viroids</a:t>
            </a:r>
            <a:endParaRPr lang="en-US" sz="800" dirty="0">
              <a:latin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56938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</TotalTime>
  <Words>1572</Words>
  <Application>Microsoft Office PowerPoint</Application>
  <PresentationFormat>A4 Paper (210x297 mm)</PresentationFormat>
  <Paragraphs>1317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hily</dc:creator>
  <cp:lastModifiedBy>Ruddock, Jim - Oxford</cp:lastModifiedBy>
  <cp:revision>7</cp:revision>
  <dcterms:created xsi:type="dcterms:W3CDTF">2017-05-10T16:38:11Z</dcterms:created>
  <dcterms:modified xsi:type="dcterms:W3CDTF">2017-05-22T08:31:59Z</dcterms:modified>
</cp:coreProperties>
</file>